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77" r:id="rId3"/>
    <p:sldId id="285" r:id="rId4"/>
    <p:sldId id="289" r:id="rId5"/>
    <p:sldId id="28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5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7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4827D1-7AD3-4E88-A358-A6798AD58393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C88DB4-2A6E-42B1-BCC3-4EBEDE2DEB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8026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76C64-D33D-4875-B15B-228CEFBE96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C6523E-17EF-46C9-BF86-156230CDEE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FB2AFA-C4D8-4765-B2E5-ABFBC2BED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F08413-C71C-4AF7-BAF9-5870A3C15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6C0AB-215D-4BA6-BC08-1B600502A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364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F5230-EC24-4DBB-9563-9DB5B65E0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55CF2B-D7C1-4A31-BA7E-A3DCF81335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B722E-F96C-423B-808C-29FA16990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32C0F7-3EA5-4E97-939D-C7E0F905D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AB3E83-3ED2-43CA-A9E7-614AF721E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436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A2AEE2-BB6F-41BE-B671-91C5DFA3E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FEBC65-9CD2-4627-8E7A-2720A584B8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4B67C-BBDF-49C2-A091-1442A8467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89511D-4CDC-4C6A-A2AF-F6633BA91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3787-2F9D-49B6-8BB7-A488CA8C2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76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2EC6C4-7FBE-42A2-B734-93DFEB011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638551-11BA-4EB5-9E96-6168DBA519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93B23A-46A1-406E-A2AF-8A4B2BA49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1499FE-6A6C-4582-9C56-97D9D748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46AA1E-3717-41E1-A484-DE7085AAA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322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64FC0-9A2E-46D4-B7E0-05F894602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0DCBD9-9643-4C4E-9677-56E0C8A07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78B851-02C1-4090-A082-A685751DD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0047AC-A010-40BA-A187-6D6F505B8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B46E82-7B89-4EF8-9D64-843A66666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403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6BF35-756B-484C-8B11-7BDD165DC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2D1C3C-7070-4932-8228-9808CD8B7F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54B94D-0CB6-43DE-B2F8-8AD49E3C4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78ABD7-BF13-4ED1-818C-7FF2961D3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E7F51-C22C-4329-88BE-06F827FB3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EA249C-0FB6-424F-BD62-21CD5683E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39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9331E-5A70-4F63-A740-5226DEABA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B0BDA8-1BB0-4DD7-91AE-EADC457B35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47E6A5-AE1F-4978-B903-9F2708B6A1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248BFB-77F4-4973-83A4-25DC1C0607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7CA3D4-1FBD-48BA-BAE3-17B63DD8B7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C03382-9714-4F2C-9F18-1B40257A6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34CB18-929B-4DCF-AEB6-21448397A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AA2E40-5D07-4E35-A00E-4939D799D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816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724C89-092F-4DFB-BD84-F157CAAAD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0EE58E-3234-4FB0-BE57-F823E9646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2CBD56-EC62-4987-B5CB-67362BCA0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A09406-1DF3-4C2C-BB04-8EFB7E6F9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900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AA88CA-3BD1-4805-B105-640662AA3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8C8933-0304-4E72-9E11-C6C597717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7D63E6-2250-450C-9E17-17D4B9B43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89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01CF4-5A5D-49DA-B5AC-A0257B484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0F8D6-2EE6-47FF-A9EB-34C915C6E2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2D3E31-7E06-4995-91A7-14CBE420A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D75B8C-5211-40A7-B1C8-9BD953156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9E7157-FA15-4A4E-89FB-59CB881D1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2987C-CD51-4CA5-8A0F-3147D5D2C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58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951FC-5180-4D7F-825B-8B760A3BD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48BB3D-F710-4624-A86F-7F0A7282E6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ACD5C8-FC42-4335-BE62-7E75A70590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F82B0A-E6FC-4EC6-A042-CAB72B691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432FA7-C471-4914-A421-C1504DB34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56C283-6E50-4BB8-9DF4-28F4F9A13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298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3CECF1-CADE-48BD-864E-12E0DFF19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AA4DEB-A1A0-4BA6-BBCF-7EE25F0CF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7CDF24-DD2C-46FE-B9F2-FDCFB9D539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A1D74-C884-4593-AB7D-CC45B69C1709}" type="datetimeFigureOut">
              <a:rPr lang="en-US" smtClean="0"/>
              <a:t>2025/0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488C3C-44BC-4F19-86A6-78CC169A5B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82FB53-8922-4D08-82D1-59D269B8A6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FB9FE-3A98-436A-B65B-8155CB16A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03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tm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tm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A0C9F-0AC4-4612-87E6-6640752E60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1016950"/>
            <a:ext cx="12192000" cy="1797576"/>
          </a:xfrm>
        </p:spPr>
        <p:txBody>
          <a:bodyPr>
            <a:normAutofit/>
          </a:bodyPr>
          <a:lstStyle/>
          <a:p>
            <a:r>
              <a:rPr lang="en-US" sz="6000" u="sng" kern="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spicious Looking </a:t>
            </a:r>
            <a:r>
              <a:rPr lang="en-ZA" sz="6000" u="sng" kern="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Mu Rhythm on SEE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1337F9F9-8E94-4E18-CC41-8E5E553A559D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itle 1">
            <a:extLst>
              <a:ext uri="{FF2B5EF4-FFF2-40B4-BE49-F238E27FC236}">
                <a16:creationId xmlns:a16="http://schemas.microsoft.com/office/drawing/2014/main" id="{AF6877E5-15A1-EF06-6B68-5B78D5AB3E58}"/>
              </a:ext>
            </a:extLst>
          </p:cNvPr>
          <p:cNvSpPr txBox="1">
            <a:spLocks/>
          </p:cNvSpPr>
          <p:nvPr/>
        </p:nvSpPr>
        <p:spPr>
          <a:xfrm>
            <a:off x="-54104" y="3682582"/>
            <a:ext cx="12192000" cy="71510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000" i="1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yesha Soni, Ana </a:t>
            </a:r>
            <a:r>
              <a:rPr lang="en-US" sz="4000" i="1" dirty="0" err="1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ller</a:t>
            </a:r>
            <a:r>
              <a:rPr lang="en-US" sz="4000" i="1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arti, Giovanni Pellegrino</a:t>
            </a:r>
            <a:endParaRPr lang="en-US" sz="3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5157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ZA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u rhythm, within the alpha band, is blocked by contralateral voluntary movement, a somatosensory stimulation or passive movement. Its generating sources are located at the somatosensory cortex. 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ZA" sz="1800" kern="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Literature on the appearance of normal variants in SEEG is lacking. 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 39-year-old gentleman </a:t>
            </a:r>
            <a:r>
              <a:rPr lang="en-US" sz="18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as investigated with</a:t>
            </a: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SEEG, in the context of multiple cavernomas (left posterior frontal and left parietal) and recurrent seizures despite left amygdalectomy. 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ecordings demonstrated abundant to continuous sharply contoured 13 Hz activity over LCav 7-10 in long runs, which was initially suspected to be epileptiform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18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ith right hand movement and sleep, the discharges consistently attenuated in contrast to other epileptiform discharges, leading us to conclude that it was a mu rhythm. 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endParaRPr lang="en-ZA" sz="18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991080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oduction and 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35842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1172772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: </a:t>
            </a:r>
            <a:r>
              <a:rPr lang="en-ZA" kern="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EEG recording demonstrating abundant sharply contoured 13 Hz activity over LCav 7-10. Inset of coronal and sagittal MRI brain showing the left parietal cavernoma and the position of the SEEG electrode close to it, with affected contacts circled in red.</a:t>
            </a:r>
            <a:r>
              <a:rPr lang="en-ZA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631AA68C-E2C9-B0E0-B2AE-27281292D16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17" r="4182" b="8235"/>
          <a:stretch/>
        </p:blipFill>
        <p:spPr>
          <a:xfrm>
            <a:off x="524195" y="877145"/>
            <a:ext cx="10562540" cy="508423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194F680-1EB9-2D24-0ED9-C1988717AA6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2384" t="28007" r="8598" b="21402"/>
          <a:stretch/>
        </p:blipFill>
        <p:spPr>
          <a:xfrm>
            <a:off x="7702600" y="963040"/>
            <a:ext cx="3384135" cy="1659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304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118227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2: </a:t>
            </a:r>
            <a:r>
              <a:rPr lang="en-ZA" sz="180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reviously described activity demonstrating attenuation with right hand movements, reappearing once it was stopped</a:t>
            </a:r>
            <a:endParaRPr lang="en-ZA" sz="18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 descr="A screenshot of a computer&#10;&#10;Description automatically generated">
            <a:extLst>
              <a:ext uri="{FF2B5EF4-FFF2-40B4-BE49-F238E27FC236}">
                <a16:creationId xmlns:a16="http://schemas.microsoft.com/office/drawing/2014/main" id="{FF507E08-884D-928C-610E-62CB06E9AB2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76" r="3972" b="8364"/>
          <a:stretch/>
        </p:blipFill>
        <p:spPr>
          <a:xfrm>
            <a:off x="491768" y="641717"/>
            <a:ext cx="10983771" cy="52513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04767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1061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ussion and Conclus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C118B30C-1AA3-2D80-0ACF-EF462D72F3C6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1800" kern="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To our knowledge, there is only one other study which assessed mu in three patients with SEEG.</a:t>
            </a:r>
          </a:p>
          <a:p>
            <a:pPr marL="457200" marR="0" lvl="0" indent="-457200" algn="just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are should be taken that physiological rhythms on SEEG are not mistaken for epileptiform activity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</a:p>
          <a:p>
            <a:pPr marL="457200" marR="0" lvl="0" indent="-457200" algn="just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hen in doubt, reactivity and activity protocols can be helpful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119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97</TotalTime>
  <Words>259</Words>
  <Application>Microsoft Office PowerPoint</Application>
  <PresentationFormat>Widescreen</PresentationFormat>
  <Paragraphs>1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Times New Roman</vt:lpstr>
      <vt:lpstr>Office Theme</vt:lpstr>
      <vt:lpstr>Suspicious Looking Mu Rhythm on SEEG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minent ocular artifact from atypical ocular bobbing</dc:title>
  <dc:creator>Roohi Katyal</dc:creator>
  <cp:lastModifiedBy>Aayesha Soni</cp:lastModifiedBy>
  <cp:revision>60</cp:revision>
  <dcterms:created xsi:type="dcterms:W3CDTF">2021-09-03T02:53:53Z</dcterms:created>
  <dcterms:modified xsi:type="dcterms:W3CDTF">2025-01-24T17:12:14Z</dcterms:modified>
</cp:coreProperties>
</file>